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90" autoAdjust="0"/>
    <p:restoredTop sz="94660"/>
  </p:normalViewPr>
  <p:slideViewPr>
    <p:cSldViewPr snapToGrid="0">
      <p:cViewPr varScale="1">
        <p:scale>
          <a:sx n="66" d="100"/>
          <a:sy n="66" d="100"/>
        </p:scale>
        <p:origin x="1504" y="52"/>
      </p:cViewPr>
      <p:guideLst>
        <p:guide orient="horz" pos="213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462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177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16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427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119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73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398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2303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173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851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6371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3149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FCA8A90A-836E-4A69-BBDC-76B1264D0C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4166977" y="1418831"/>
            <a:ext cx="6336000" cy="359459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7642D5A-3E79-46EB-8E93-313BC894945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585407" y="1418832"/>
            <a:ext cx="6336000" cy="3594596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709DE782-27B4-4D52-AE34-5A3254408B09}"/>
              </a:ext>
            </a:extLst>
          </p:cNvPr>
          <p:cNvSpPr/>
          <p:nvPr/>
        </p:nvSpPr>
        <p:spPr>
          <a:xfrm>
            <a:off x="458942" y="129779"/>
            <a:ext cx="381496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 Relative time of flowering and emergence of leaves</a:t>
            </a:r>
            <a:endParaRPr lang="zh-CN" altLang="en-US" sz="1200" b="1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E92C51AC-DD04-46E2-AA54-1330E3A5E7E1}"/>
              </a:ext>
            </a:extLst>
          </p:cNvPr>
          <p:cNvGrpSpPr/>
          <p:nvPr/>
        </p:nvGrpSpPr>
        <p:grpSpPr>
          <a:xfrm>
            <a:off x="629672" y="412239"/>
            <a:ext cx="3035496" cy="731925"/>
            <a:chOff x="629672" y="471937"/>
            <a:chExt cx="3035496" cy="731925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BD591922-DE71-4415-B201-83D1132C3FED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9672" y="518434"/>
              <a:ext cx="270000" cy="223762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1C55C65C-1A5E-44F9-9DC6-E1F488A288BF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9672" y="980100"/>
              <a:ext cx="270000" cy="223762"/>
            </a:xfrm>
            <a:prstGeom prst="rect">
              <a:avLst/>
            </a:prstGeom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F99F0F9C-6B01-424F-9A6B-E9A063410388}"/>
                </a:ext>
              </a:extLst>
            </p:cNvPr>
            <p:cNvSpPr/>
            <p:nvPr/>
          </p:nvSpPr>
          <p:spPr>
            <a:xfrm>
              <a:off x="799786" y="471937"/>
              <a:ext cx="2865382" cy="2702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 leaves emerge </a:t>
              </a:r>
            </a:p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precocious and </a:t>
              </a:r>
              <a:r>
                <a:rPr lang="en-US" altLang="zh-C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bprecocious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24458D36-F30A-4509-A55B-7669F5AF9D13}"/>
                </a:ext>
              </a:extLst>
            </p:cNvPr>
            <p:cNvSpPr/>
            <p:nvPr/>
          </p:nvSpPr>
          <p:spPr>
            <a:xfrm>
              <a:off x="799786" y="918193"/>
              <a:ext cx="2042996" cy="2702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 leaves emerge (coetaneous 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serotinous)</a:t>
              </a:r>
            </a:p>
          </p:txBody>
        </p:sp>
      </p:grpSp>
      <p:sp>
        <p:nvSpPr>
          <p:cNvPr id="18" name="矩形 17">
            <a:extLst>
              <a:ext uri="{FF2B5EF4-FFF2-40B4-BE49-F238E27FC236}">
                <a16:creationId xmlns:a16="http://schemas.microsoft.com/office/drawing/2014/main" id="{AD2A617F-E415-4052-A9EE-4422D80AD5DD}"/>
              </a:ext>
            </a:extLst>
          </p:cNvPr>
          <p:cNvSpPr/>
          <p:nvPr/>
        </p:nvSpPr>
        <p:spPr>
          <a:xfrm>
            <a:off x="738106" y="6387894"/>
            <a:ext cx="85252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4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imum Parsimony ancestral state reconstruction of relative time of flowering and emergence of leaves (A) and catkin peduncle leaf type (B) based on relationships revealed by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xM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e of the m15 reduced dataset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4C77EDE9-0DDE-4A57-872F-B5473A17FB6F}"/>
              </a:ext>
            </a:extLst>
          </p:cNvPr>
          <p:cNvGrpSpPr/>
          <p:nvPr/>
        </p:nvGrpSpPr>
        <p:grpSpPr>
          <a:xfrm>
            <a:off x="6702405" y="412239"/>
            <a:ext cx="2403809" cy="907920"/>
            <a:chOff x="6702405" y="412239"/>
            <a:chExt cx="2403809" cy="907920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BA8A5B97-055E-422B-8FD1-5FC54573CED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2405" y="458736"/>
              <a:ext cx="269428" cy="223762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6B71A467-DB43-4D65-99C8-FB4732AEDA3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2405" y="920400"/>
              <a:ext cx="269428" cy="223762"/>
            </a:xfrm>
            <a:prstGeom prst="rect">
              <a:avLst/>
            </a:prstGeom>
          </p:spPr>
        </p:pic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3EF1803F-39AD-47AD-862F-F0B37F827BF1}"/>
                </a:ext>
              </a:extLst>
            </p:cNvPr>
            <p:cNvSpPr/>
            <p:nvPr/>
          </p:nvSpPr>
          <p:spPr>
            <a:xfrm>
              <a:off x="6837118" y="412239"/>
              <a:ext cx="2269096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acteate (leaves smaller and distinct from vegetative ones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02612B6C-15C1-4497-A554-60D18B17811E}"/>
                </a:ext>
              </a:extLst>
            </p:cNvPr>
            <p:cNvSpPr/>
            <p:nvPr/>
          </p:nvSpPr>
          <p:spPr>
            <a:xfrm>
              <a:off x="6837118" y="858494"/>
              <a:ext cx="225619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iate (leaflet nearly as large and</a:t>
              </a:r>
            </a:p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liated as vegetative ones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" name="矩形 24">
            <a:extLst>
              <a:ext uri="{FF2B5EF4-FFF2-40B4-BE49-F238E27FC236}">
                <a16:creationId xmlns:a16="http://schemas.microsoft.com/office/drawing/2014/main" id="{DF48F5DA-C70D-481F-9F4A-0311D528F16E}"/>
              </a:ext>
            </a:extLst>
          </p:cNvPr>
          <p:cNvSpPr/>
          <p:nvPr/>
        </p:nvSpPr>
        <p:spPr>
          <a:xfrm>
            <a:off x="6702405" y="129779"/>
            <a:ext cx="381496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 Catkin peduncle leaf type</a:t>
            </a:r>
            <a:endParaRPr lang="zh-CN" altLang="en-US" sz="1200" b="1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FCE72BC-F879-494A-B4B6-C7E8480D6F3A}"/>
              </a:ext>
            </a:extLst>
          </p:cNvPr>
          <p:cNvSpPr txBox="1"/>
          <p:nvPr/>
        </p:nvSpPr>
        <p:spPr>
          <a:xfrm rot="2531340">
            <a:off x="6405023" y="1385223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Ⅱ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9CACA43-F675-47BE-BB2A-87FA54CE2225}"/>
              </a:ext>
            </a:extLst>
          </p:cNvPr>
          <p:cNvSpPr txBox="1"/>
          <p:nvPr/>
        </p:nvSpPr>
        <p:spPr>
          <a:xfrm rot="19033879">
            <a:off x="2565718" y="1377950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Ⅱ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0F94D2B2-4BA7-4CE4-A2AC-8CF5EE5BCFD4}"/>
              </a:ext>
            </a:extLst>
          </p:cNvPr>
          <p:cNvSpPr/>
          <p:nvPr/>
        </p:nvSpPr>
        <p:spPr>
          <a:xfrm>
            <a:off x="4262819" y="-38498"/>
            <a:ext cx="1325013" cy="65501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einom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simanth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s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nestii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gnific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ilostigm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ner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fredii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lonom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cf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bellaris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dleyan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ltonian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ect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opanth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itreph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eilophil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egat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pure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cilistyl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marinifoli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ens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hderian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minalis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stat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endiculat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reticulata</a:t>
            </a:r>
          </a:p>
          <a:p>
            <a:pPr algn="ctr">
              <a:lnSpc>
                <a:spcPct val="130000"/>
              </a:lnSpc>
            </a:pP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andra</a:t>
            </a:r>
            <a:endParaRPr lang="en-US" altLang="zh-CN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764001A2-FB70-4D00-B3D9-BF7B6A4A63AE}"/>
              </a:ext>
            </a:extLst>
          </p:cNvPr>
          <p:cNvSpPr txBox="1"/>
          <p:nvPr/>
        </p:nvSpPr>
        <p:spPr>
          <a:xfrm rot="2577868">
            <a:off x="2667237" y="2020628"/>
            <a:ext cx="8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Ⅰ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B773D07-B3D3-4225-A1A0-329D27FEBD09}"/>
              </a:ext>
            </a:extLst>
          </p:cNvPr>
          <p:cNvSpPr txBox="1"/>
          <p:nvPr/>
        </p:nvSpPr>
        <p:spPr>
          <a:xfrm rot="19076542">
            <a:off x="6236400" y="2105965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 Ⅰ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57FB2C1-C9AE-48B6-AE07-24911C62AA56}"/>
              </a:ext>
            </a:extLst>
          </p:cNvPr>
          <p:cNvSpPr txBox="1"/>
          <p:nvPr/>
        </p:nvSpPr>
        <p:spPr>
          <a:xfrm rot="19085087">
            <a:off x="1019928" y="2360208"/>
            <a:ext cx="18437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gduan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untains clade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8D53B82-B937-4C82-80CB-52A2C5CBB5EE}"/>
              </a:ext>
            </a:extLst>
          </p:cNvPr>
          <p:cNvSpPr txBox="1"/>
          <p:nvPr/>
        </p:nvSpPr>
        <p:spPr>
          <a:xfrm rot="2537653">
            <a:off x="1562076" y="3534370"/>
            <a:ext cx="1164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asian clade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FBDDCE96-8610-4682-B050-4F7961D5217A}"/>
              </a:ext>
            </a:extLst>
          </p:cNvPr>
          <p:cNvSpPr txBox="1"/>
          <p:nvPr/>
        </p:nvSpPr>
        <p:spPr>
          <a:xfrm rot="2530891">
            <a:off x="7078794" y="2380813"/>
            <a:ext cx="18437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gduan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untains clade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F34FCD09-D9EF-4AF1-8C08-D41B92A0AE9A}"/>
              </a:ext>
            </a:extLst>
          </p:cNvPr>
          <p:cNvSpPr txBox="1"/>
          <p:nvPr/>
        </p:nvSpPr>
        <p:spPr>
          <a:xfrm rot="19067174">
            <a:off x="7187149" y="3529711"/>
            <a:ext cx="1164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asian clade</a:t>
            </a:r>
          </a:p>
        </p:txBody>
      </p:sp>
    </p:spTree>
    <p:extLst>
      <p:ext uri="{BB962C8B-B14F-4D97-AF65-F5344CB8AC3E}">
        <p14:creationId xmlns:p14="http://schemas.microsoft.com/office/powerpoint/2010/main" val="336440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8</TotalTime>
  <Words>197</Words>
  <Application>Microsoft Office PowerPoint</Application>
  <PresentationFormat>A4 纸张(210x297 毫米)</PresentationFormat>
  <Paragraphs>4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alix10</dc:creator>
  <cp:lastModifiedBy>salix10</cp:lastModifiedBy>
  <cp:revision>74</cp:revision>
  <dcterms:created xsi:type="dcterms:W3CDTF">2019-01-03T08:08:44Z</dcterms:created>
  <dcterms:modified xsi:type="dcterms:W3CDTF">2019-12-11T07:33:47Z</dcterms:modified>
</cp:coreProperties>
</file>